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40538" cy="8280400"/>
  <p:notesSz cx="6888163" cy="100203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31" userDrawn="1">
          <p15:clr>
            <a:srgbClr val="A4A3A4"/>
          </p15:clr>
        </p15:guide>
        <p15:guide id="2" pos="215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93" d="100"/>
          <a:sy n="93" d="100"/>
        </p:scale>
        <p:origin x="2694" y="90"/>
      </p:cViewPr>
      <p:guideLst>
        <p:guide orient="horz" pos="2631"/>
        <p:guide pos="215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1355149"/>
            <a:ext cx="5814457" cy="2882806"/>
          </a:xfrm>
        </p:spPr>
        <p:txBody>
          <a:bodyPr anchor="b"/>
          <a:lstStyle>
            <a:lvl1pPr algn="ctr">
              <a:defRPr sz="4489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5067" y="4349128"/>
            <a:ext cx="5130404" cy="1999179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031" indent="0" algn="ctr">
              <a:buNone/>
              <a:defRPr sz="1496"/>
            </a:lvl2pPr>
            <a:lvl3pPr marL="684063" indent="0" algn="ctr">
              <a:buNone/>
              <a:defRPr sz="1347"/>
            </a:lvl3pPr>
            <a:lvl4pPr marL="1026094" indent="0" algn="ctr">
              <a:buNone/>
              <a:defRPr sz="1197"/>
            </a:lvl4pPr>
            <a:lvl5pPr marL="1368125" indent="0" algn="ctr">
              <a:buNone/>
              <a:defRPr sz="1197"/>
            </a:lvl5pPr>
            <a:lvl6pPr marL="1710157" indent="0" algn="ctr">
              <a:buNone/>
              <a:defRPr sz="1197"/>
            </a:lvl6pPr>
            <a:lvl7pPr marL="2052188" indent="0" algn="ctr">
              <a:buNone/>
              <a:defRPr sz="1197"/>
            </a:lvl7pPr>
            <a:lvl8pPr marL="2394219" indent="0" algn="ctr">
              <a:buNone/>
              <a:defRPr sz="1197"/>
            </a:lvl8pPr>
            <a:lvl9pPr marL="2736251" indent="0" algn="ctr">
              <a:buNone/>
              <a:defRPr sz="1197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32824-045A-46AA-A68D-EB22E9A8E7CD}" type="datetimeFigureOut">
              <a:rPr lang="it-IT" smtClean="0"/>
              <a:t>24/02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15E2-B9AE-4BF0-8325-07738E1ED8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862772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32824-045A-46AA-A68D-EB22E9A8E7CD}" type="datetimeFigureOut">
              <a:rPr lang="it-IT" smtClean="0"/>
              <a:t>24/02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15E2-B9AE-4BF0-8325-07738E1ED8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98661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95260" y="440855"/>
            <a:ext cx="1474991" cy="7017256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0288" y="440855"/>
            <a:ext cx="4339466" cy="7017256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32824-045A-46AA-A68D-EB22E9A8E7CD}" type="datetimeFigureOut">
              <a:rPr lang="it-IT" smtClean="0"/>
              <a:t>24/02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15E2-B9AE-4BF0-8325-07738E1ED8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375821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32824-045A-46AA-A68D-EB22E9A8E7CD}" type="datetimeFigureOut">
              <a:rPr lang="it-IT" smtClean="0"/>
              <a:t>24/02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15E2-B9AE-4BF0-8325-07738E1ED8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160245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725" y="2064352"/>
            <a:ext cx="5899964" cy="3444416"/>
          </a:xfrm>
        </p:spPr>
        <p:txBody>
          <a:bodyPr anchor="b"/>
          <a:lstStyle>
            <a:lvl1pPr>
              <a:defRPr sz="4489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6725" y="5541353"/>
            <a:ext cx="5899964" cy="1811337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/>
                </a:solidFill>
              </a:defRPr>
            </a:lvl1pPr>
            <a:lvl2pPr marL="342031" indent="0">
              <a:buNone/>
              <a:defRPr sz="1496">
                <a:solidFill>
                  <a:schemeClr val="tx1">
                    <a:tint val="75000"/>
                  </a:schemeClr>
                </a:solidFill>
              </a:defRPr>
            </a:lvl2pPr>
            <a:lvl3pPr marL="684063" indent="0">
              <a:buNone/>
              <a:defRPr sz="1347">
                <a:solidFill>
                  <a:schemeClr val="tx1">
                    <a:tint val="75000"/>
                  </a:schemeClr>
                </a:solidFill>
              </a:defRPr>
            </a:lvl3pPr>
            <a:lvl4pPr marL="1026094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4pPr>
            <a:lvl5pPr marL="1368125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5pPr>
            <a:lvl6pPr marL="1710157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6pPr>
            <a:lvl7pPr marL="2052188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7pPr>
            <a:lvl8pPr marL="2394219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8pPr>
            <a:lvl9pPr marL="2736251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32824-045A-46AA-A68D-EB22E9A8E7CD}" type="datetimeFigureOut">
              <a:rPr lang="it-IT" smtClean="0"/>
              <a:t>24/02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15E2-B9AE-4BF0-8325-07738E1ED8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5921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0287" y="2204273"/>
            <a:ext cx="2907229" cy="52538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3022" y="2204273"/>
            <a:ext cx="2907229" cy="52538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32824-045A-46AA-A68D-EB22E9A8E7CD}" type="datetimeFigureOut">
              <a:rPr lang="it-IT" smtClean="0"/>
              <a:t>24/02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15E2-B9AE-4BF0-8325-07738E1ED8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936595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440856"/>
            <a:ext cx="5899964" cy="160049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179" y="2029849"/>
            <a:ext cx="2893868" cy="994797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179" y="3024646"/>
            <a:ext cx="2893868" cy="4448799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3023" y="2029849"/>
            <a:ext cx="2908120" cy="994797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3023" y="3024646"/>
            <a:ext cx="2908120" cy="4448799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32824-045A-46AA-A68D-EB22E9A8E7CD}" type="datetimeFigureOut">
              <a:rPr lang="it-IT" smtClean="0"/>
              <a:t>24/02/2021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15E2-B9AE-4BF0-8325-07738E1ED8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726681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32824-045A-46AA-A68D-EB22E9A8E7CD}" type="datetimeFigureOut">
              <a:rPr lang="it-IT" smtClean="0"/>
              <a:t>24/02/2021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15E2-B9AE-4BF0-8325-07738E1ED8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000688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32824-045A-46AA-A68D-EB22E9A8E7CD}" type="datetimeFigureOut">
              <a:rPr lang="it-IT" smtClean="0"/>
              <a:t>24/02/2021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15E2-B9AE-4BF0-8325-07738E1ED8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30076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552027"/>
            <a:ext cx="2206252" cy="1932093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8120" y="1192226"/>
            <a:ext cx="3463022" cy="5884451"/>
          </a:xfrm>
        </p:spPr>
        <p:txBody>
          <a:bodyPr/>
          <a:lstStyle>
            <a:lvl1pPr>
              <a:defRPr sz="2394"/>
            </a:lvl1pPr>
            <a:lvl2pPr>
              <a:defRPr sz="2095"/>
            </a:lvl2pPr>
            <a:lvl3pPr>
              <a:defRPr sz="1795"/>
            </a:lvl3pPr>
            <a:lvl4pPr>
              <a:defRPr sz="1496"/>
            </a:lvl4pPr>
            <a:lvl5pPr>
              <a:defRPr sz="1496"/>
            </a:lvl5pPr>
            <a:lvl6pPr>
              <a:defRPr sz="1496"/>
            </a:lvl6pPr>
            <a:lvl7pPr>
              <a:defRPr sz="1496"/>
            </a:lvl7pPr>
            <a:lvl8pPr>
              <a:defRPr sz="1496"/>
            </a:lvl8pPr>
            <a:lvl9pPr>
              <a:defRPr sz="1496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484120"/>
            <a:ext cx="2206252" cy="4602140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32824-045A-46AA-A68D-EB22E9A8E7CD}" type="datetimeFigureOut">
              <a:rPr lang="it-IT" smtClean="0"/>
              <a:t>24/02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15E2-B9AE-4BF0-8325-07738E1ED8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342696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552027"/>
            <a:ext cx="2206252" cy="1932093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08120" y="1192226"/>
            <a:ext cx="3463022" cy="5884451"/>
          </a:xfrm>
        </p:spPr>
        <p:txBody>
          <a:bodyPr anchor="t"/>
          <a:lstStyle>
            <a:lvl1pPr marL="0" indent="0">
              <a:buNone/>
              <a:defRPr sz="2394"/>
            </a:lvl1pPr>
            <a:lvl2pPr marL="342031" indent="0">
              <a:buNone/>
              <a:defRPr sz="2095"/>
            </a:lvl2pPr>
            <a:lvl3pPr marL="684063" indent="0">
              <a:buNone/>
              <a:defRPr sz="1795"/>
            </a:lvl3pPr>
            <a:lvl4pPr marL="1026094" indent="0">
              <a:buNone/>
              <a:defRPr sz="1496"/>
            </a:lvl4pPr>
            <a:lvl5pPr marL="1368125" indent="0">
              <a:buNone/>
              <a:defRPr sz="1496"/>
            </a:lvl5pPr>
            <a:lvl6pPr marL="1710157" indent="0">
              <a:buNone/>
              <a:defRPr sz="1496"/>
            </a:lvl6pPr>
            <a:lvl7pPr marL="2052188" indent="0">
              <a:buNone/>
              <a:defRPr sz="1496"/>
            </a:lvl7pPr>
            <a:lvl8pPr marL="2394219" indent="0">
              <a:buNone/>
              <a:defRPr sz="1496"/>
            </a:lvl8pPr>
            <a:lvl9pPr marL="2736251" indent="0">
              <a:buNone/>
              <a:defRPr sz="1496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484120"/>
            <a:ext cx="2206252" cy="4602140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32824-045A-46AA-A68D-EB22E9A8E7CD}" type="datetimeFigureOut">
              <a:rPr lang="it-IT" smtClean="0"/>
              <a:t>24/02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15E2-B9AE-4BF0-8325-07738E1ED8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80988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0287" y="440856"/>
            <a:ext cx="5899964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0287" y="2204273"/>
            <a:ext cx="5899964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0287" y="7674706"/>
            <a:ext cx="1539121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532824-045A-46AA-A68D-EB22E9A8E7CD}" type="datetimeFigureOut">
              <a:rPr lang="it-IT" smtClean="0"/>
              <a:t>24/02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65928" y="7674706"/>
            <a:ext cx="2308682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31130" y="7674706"/>
            <a:ext cx="1539121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E815E2-B9AE-4BF0-8325-07738E1ED8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84377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4063" rtl="0" eaLnBrk="1" latinLnBrk="0" hangingPunct="1">
        <a:lnSpc>
          <a:spcPct val="90000"/>
        </a:lnSpc>
        <a:spcBef>
          <a:spcPct val="0"/>
        </a:spcBef>
        <a:buNone/>
        <a:defRPr sz="32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016" indent="-171016" algn="l" defTabSz="684063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47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5078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496" kern="1200">
          <a:solidFill>
            <a:schemeClr val="tx1"/>
          </a:solidFill>
          <a:latin typeface="+mn-lt"/>
          <a:ea typeface="+mn-ea"/>
          <a:cs typeface="+mn-cs"/>
        </a:defRPr>
      </a:lvl3pPr>
      <a:lvl4pPr marL="1197110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539141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881172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223204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565235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907266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1pPr>
      <a:lvl2pPr marL="34203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2pPr>
      <a:lvl3pPr marL="684063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26094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368125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710157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052188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394219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73625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376371" y="268941"/>
            <a:ext cx="61618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4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rincipal Component Analysis (PCA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iagram of the first two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xes from a PCA of cowpea and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cultigrou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esquipedalis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, and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Italian and Iraqi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wpeas (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magin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5573" y="4716954"/>
            <a:ext cx="4554437" cy="2577311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Immagin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93686" y="1561732"/>
            <a:ext cx="4554437" cy="2780907"/>
          </a:xfrm>
          <a:prstGeom prst="rect">
            <a:avLst/>
          </a:prstGeom>
          <a:ln>
            <a:noFill/>
          </a:ln>
        </p:spPr>
      </p:pic>
      <p:sp>
        <p:nvSpPr>
          <p:cNvPr id="7" name="Rettangolo 6"/>
          <p:cNvSpPr/>
          <p:nvPr/>
        </p:nvSpPr>
        <p:spPr>
          <a:xfrm>
            <a:off x="975573" y="4619767"/>
            <a:ext cx="4633657" cy="9718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9" name="CasellaDiTesto 28"/>
          <p:cNvSpPr txBox="1"/>
          <p:nvPr/>
        </p:nvSpPr>
        <p:spPr>
          <a:xfrm>
            <a:off x="466621" y="1672234"/>
            <a:ext cx="2005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5" name="CasellaDiTesto 34"/>
          <p:cNvSpPr txBox="1"/>
          <p:nvPr/>
        </p:nvSpPr>
        <p:spPr>
          <a:xfrm>
            <a:off x="454016" y="4619767"/>
            <a:ext cx="2874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3" name="Immagine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32420" y="1382621"/>
            <a:ext cx="1596481" cy="3582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29530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61</TotalTime>
  <Words>37</Words>
  <Application>Microsoft Office PowerPoint</Application>
  <PresentationFormat>Personalizzato</PresentationFormat>
  <Paragraphs>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</dc:creator>
  <cp:lastModifiedBy>Gabriella Sonnante</cp:lastModifiedBy>
  <cp:revision>83</cp:revision>
  <cp:lastPrinted>2020-09-11T09:18:37Z</cp:lastPrinted>
  <dcterms:created xsi:type="dcterms:W3CDTF">2020-08-24T08:40:39Z</dcterms:created>
  <dcterms:modified xsi:type="dcterms:W3CDTF">2021-02-24T14:14:05Z</dcterms:modified>
</cp:coreProperties>
</file>